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015" autoAdjust="0"/>
    <p:restoredTop sz="94660"/>
  </p:normalViewPr>
  <p:slideViewPr>
    <p:cSldViewPr snapToGrid="0">
      <p:cViewPr varScale="1">
        <p:scale>
          <a:sx n="88" d="100"/>
          <a:sy n="88" d="100"/>
        </p:scale>
        <p:origin x="10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4C6D6D-9D12-BC29-21A7-C3A73B3A0B3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86AD40B-3889-77B3-B822-92F9467CBC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716B9F-55E5-73E8-A00E-F5824CA873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5D311-433F-46A9-A45C-43C3F0210C1B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CD693F7-389D-B26C-FE00-79625D0AA7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5DDFA2-D066-91B9-81BA-793D6A1B6B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9742F-A781-4927-A0A9-718EDE3FE5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1723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C0E7F5-7265-2078-2A5A-6C432C3C85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8E2AE65-4554-1536-45CC-2BB5DB747F9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1CE9CFD-63D4-9891-78C2-69DBDFB297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5D311-433F-46A9-A45C-43C3F0210C1B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F901AC-A96E-2EDD-300C-E165A0A04D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E21F5B0-7B20-16A5-DAF0-23B9B2CEE4F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9742F-A781-4927-A0A9-718EDE3FE5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4046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248FFB3-5F56-32FA-AA7E-363576717B4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5FC60CA-DF20-E004-C096-7D3849DECAD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8B10E2-D528-6B52-FCE8-BCAA205C44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5D311-433F-46A9-A45C-43C3F0210C1B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5394FD-3905-5691-E820-4D03649C8F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A993E8-A9D1-81D8-2CE4-ED0D736E9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9742F-A781-4927-A0A9-718EDE3FE5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008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3328F2-FC5C-F2B4-A77C-6AA20F3CBF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DAAC333-7BBE-E0F4-D2EF-B7FC9004F83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9E7484D-3240-3689-0C53-8DD10180F1A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5D311-433F-46A9-A45C-43C3F0210C1B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5BB07D1-D72B-4DD2-5426-D15DB3C1F1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5BF587-1A47-05A2-C6BC-515EC151B1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9742F-A781-4927-A0A9-718EDE3FE5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1077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0B476AC-E6DE-9DC6-8750-C5365B510E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33E7482-CF79-862D-0407-AD492A0598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9840C1-6877-C883-B1EA-3BFFA573F4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5D311-433F-46A9-A45C-43C3F0210C1B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E6EDE9-A60E-0F5B-A0A7-AA5B7B9898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97E07F2-60DB-65F3-BFDB-C046FE3042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9742F-A781-4927-A0A9-718EDE3FE5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0081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8812A32-4D2C-88C8-2BC9-06DB077C4D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C06E55-70DE-2C6D-7C69-DEF4A9A28E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56AEC1-8356-8E95-60B8-F89D99BD0E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AF7D37C-9A0A-D0FB-C715-36CD234D2C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5D311-433F-46A9-A45C-43C3F0210C1B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A51E8DA-770F-2303-2055-E42196B012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EA3885-55FD-43A8-012C-27094274CF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9742F-A781-4927-A0A9-718EDE3FE5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4765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12E9670-BCD1-C88A-0C3F-2AA69F3C45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0D73254-3675-B59E-1E23-7688460A8D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1C1070E-2D53-43C8-870F-0F473942CCC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1A24D6F-B815-F435-264D-32F366F3E5A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B76B5BB-E333-1A67-7339-D0B771C2345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CA87FEF-DE70-F8EB-EF5F-8BE985E4E1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5D311-433F-46A9-A45C-43C3F0210C1B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D5829BA-D9ED-53F5-24A8-3288298221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E1ED97A-2F61-4FB1-2949-A5D468E554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9742F-A781-4927-A0A9-718EDE3FE5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76727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983DA5-F6E8-6BD9-E389-46DFF766C4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DFE10A6-A00D-C9D2-DEE3-6D4DE3ABD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5D311-433F-46A9-A45C-43C3F0210C1B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4F8147D-8935-0FEE-F9CD-9622965B8E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45963BF5-B797-A456-30C2-9B8E163E209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9742F-A781-4927-A0A9-718EDE3FE5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9441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0B2087B-D22D-0EC0-E640-BBE46774AF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5D311-433F-46A9-A45C-43C3F0210C1B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26965089-DA4E-C10C-2DC7-E44DAE3BB3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0A48B90-A072-95B2-24C7-8FDDB0D983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9742F-A781-4927-A0A9-718EDE3FE5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2526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C85C23-D2FA-472E-B9F7-2DF624326C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230476B-F8A1-86C2-7ABE-3BD13C038AC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12A021-0467-8BA9-8505-CFC1FF185E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0B0D882-C3B2-2670-B289-1F4A480BB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5D311-433F-46A9-A45C-43C3F0210C1B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210F361-192D-470B-2EF7-F2F0980867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987484C-8480-E0AA-AB1C-6BB83B435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9742F-A781-4927-A0A9-718EDE3FE5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533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2A6CDC-1DE4-6EF8-90F9-F7FA6EE92D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E4BA0B8-D4CA-3460-5590-C256D857DA5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F324E7F-9C0C-ACF2-4C28-98886EBF59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58F355-EE82-4295-7BE3-0327DA6A19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55D311-433F-46A9-A45C-43C3F0210C1B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15FFCD9-4955-81D5-508D-DC8BADC254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D26288A-6A75-FB1E-9228-DBF5C073A9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309742F-A781-4927-A0A9-718EDE3FE5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44767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6E72DE5-CF10-2FF7-B75D-AF8A6B7C69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E49EDCD-8C79-CAE8-79C2-375B00F4FDC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957E29F-B5CC-02D3-4C56-E95BDB7CD3F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155D311-433F-46A9-A45C-43C3F0210C1B}" type="datetimeFigureOut">
              <a:rPr lang="en-US" smtClean="0"/>
              <a:t>6/14/20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0B9D36A-54EF-E17B-110E-61F07FC23C1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65C89A3-9F08-7D09-F5AF-8648DCACEC1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309742F-A781-4927-A0A9-718EDE3FE52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493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F30684EA-F659-3185-499C-368B0E7062C9}"/>
              </a:ext>
            </a:extLst>
          </p:cNvPr>
          <p:cNvGrpSpPr/>
          <p:nvPr/>
        </p:nvGrpSpPr>
        <p:grpSpPr>
          <a:xfrm>
            <a:off x="263582" y="994787"/>
            <a:ext cx="11575909" cy="3998633"/>
            <a:chOff x="831404" y="2395529"/>
            <a:chExt cx="8781467" cy="2861026"/>
          </a:xfrm>
        </p:grpSpPr>
        <p:grpSp>
          <p:nvGrpSpPr>
            <p:cNvPr id="6" name="Group 5">
              <a:extLst>
                <a:ext uri="{FF2B5EF4-FFF2-40B4-BE49-F238E27FC236}">
                  <a16:creationId xmlns:a16="http://schemas.microsoft.com/office/drawing/2014/main" id="{8109F284-B378-891E-18E1-770391EB9886}"/>
                </a:ext>
              </a:extLst>
            </p:cNvPr>
            <p:cNvGrpSpPr/>
            <p:nvPr/>
          </p:nvGrpSpPr>
          <p:grpSpPr>
            <a:xfrm>
              <a:off x="831404" y="2395529"/>
              <a:ext cx="8781467" cy="2861026"/>
              <a:chOff x="831404" y="2395529"/>
              <a:chExt cx="8781467" cy="2861026"/>
            </a:xfrm>
          </p:grpSpPr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9F7538CE-437C-6034-F787-B71391BBC862}"/>
                  </a:ext>
                </a:extLst>
              </p:cNvPr>
              <p:cNvSpPr txBox="1"/>
              <p:nvPr/>
            </p:nvSpPr>
            <p:spPr>
              <a:xfrm>
                <a:off x="1292350" y="2402315"/>
                <a:ext cx="858759" cy="23105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Quiescent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699DD20D-B520-63BE-52FB-81745710945B}"/>
                  </a:ext>
                </a:extLst>
              </p:cNvPr>
              <p:cNvSpPr txBox="1"/>
              <p:nvPr/>
            </p:nvSpPr>
            <p:spPr>
              <a:xfrm>
                <a:off x="2427314" y="2402315"/>
                <a:ext cx="1096660" cy="231058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>
                <a:defPPr>
                  <a:defRPr lang="en-US"/>
                </a:defPPr>
                <a:lvl1pPr>
                  <a:defRPr sz="800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lvl1pPr>
              </a:lstStyle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roliferating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E7BBABBE-8E09-62AE-8F4D-93D8B1DCE031}"/>
                  </a:ext>
                </a:extLst>
              </p:cNvPr>
              <p:cNvSpPr txBox="1"/>
              <p:nvPr/>
            </p:nvSpPr>
            <p:spPr>
              <a:xfrm>
                <a:off x="3728539" y="2400366"/>
                <a:ext cx="966720" cy="19819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ransitioning 1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2E50CE5D-F740-B0F2-0A7D-BDA0A2602670}"/>
                  </a:ext>
                </a:extLst>
              </p:cNvPr>
              <p:cNvSpPr txBox="1"/>
              <p:nvPr/>
            </p:nvSpPr>
            <p:spPr>
              <a:xfrm>
                <a:off x="4999564" y="2399990"/>
                <a:ext cx="1024946" cy="19819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ransitioning 2</a:t>
                </a:r>
              </a:p>
            </p:txBody>
          </p:sp>
          <p:pic>
            <p:nvPicPr>
              <p:cNvPr id="12" name="Picture 11">
                <a:extLst>
                  <a:ext uri="{FF2B5EF4-FFF2-40B4-BE49-F238E27FC236}">
                    <a16:creationId xmlns:a16="http://schemas.microsoft.com/office/drawing/2014/main" id="{AB373DC5-5055-E04B-564B-CDE83E2171C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831404" y="2835496"/>
                <a:ext cx="8781467" cy="2421059"/>
              </a:xfrm>
              <a:prstGeom prst="rect">
                <a:avLst/>
              </a:prstGeom>
            </p:spPr>
          </p:pic>
          <p:cxnSp>
            <p:nvCxnSpPr>
              <p:cNvPr id="13" name="Straight Connector 12">
                <a:extLst>
                  <a:ext uri="{FF2B5EF4-FFF2-40B4-BE49-F238E27FC236}">
                    <a16:creationId xmlns:a16="http://schemas.microsoft.com/office/drawing/2014/main" id="{25756F12-3866-2F7E-4DFF-3F9C5C49F1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80802" y="2646859"/>
                <a:ext cx="0" cy="209485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" name="Straight Connector 13">
                <a:extLst>
                  <a:ext uri="{FF2B5EF4-FFF2-40B4-BE49-F238E27FC236}">
                    <a16:creationId xmlns:a16="http://schemas.microsoft.com/office/drawing/2014/main" id="{E00F14A5-9840-42F9-2E26-3F207419C164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523974" y="2646858"/>
                <a:ext cx="0" cy="2094859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" name="Straight Connector 14">
                <a:extLst>
                  <a:ext uri="{FF2B5EF4-FFF2-40B4-BE49-F238E27FC236}">
                    <a16:creationId xmlns:a16="http://schemas.microsoft.com/office/drawing/2014/main" id="{4F9FD524-BA91-5D02-20AB-A1FE7E604A3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165197" y="2608249"/>
                <a:ext cx="0" cy="211663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Straight Connector 15">
                <a:extLst>
                  <a:ext uri="{FF2B5EF4-FFF2-40B4-BE49-F238E27FC236}">
                    <a16:creationId xmlns:a16="http://schemas.microsoft.com/office/drawing/2014/main" id="{F5FE14FA-AB0F-5EDD-9EEE-6E3E669EA0A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336482" y="2608249"/>
                <a:ext cx="0" cy="2116630"/>
              </a:xfrm>
              <a:prstGeom prst="line">
                <a:avLst/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2F1C01CF-90B0-CD32-55C0-BDC8F0C79125}"/>
                  </a:ext>
                </a:extLst>
              </p:cNvPr>
              <p:cNvSpPr txBox="1"/>
              <p:nvPr/>
            </p:nvSpPr>
            <p:spPr>
              <a:xfrm>
                <a:off x="6126350" y="2402315"/>
                <a:ext cx="1372865" cy="19819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ifferentiation low</a:t>
                </a:r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237CE97F-7EE9-D0C1-53CB-D041C6574504}"/>
                  </a:ext>
                </a:extLst>
              </p:cNvPr>
              <p:cNvSpPr txBox="1"/>
              <p:nvPr/>
            </p:nvSpPr>
            <p:spPr>
              <a:xfrm>
                <a:off x="7336482" y="2395529"/>
                <a:ext cx="1372865" cy="198193"/>
              </a:xfrm>
              <a:prstGeom prst="rect">
                <a:avLst/>
              </a:prstGeom>
              <a:noFill/>
            </p:spPr>
            <p:txBody>
              <a:bodyPr wrap="square">
                <a:spAutoFit/>
              </a:bodyPr>
              <a:lstStyle/>
              <a:p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Differentiation high</a:t>
                </a:r>
              </a:p>
            </p:txBody>
          </p:sp>
        </p:grp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5CE021A2-4138-4BE6-391F-ACC298ED0F05}"/>
                </a:ext>
              </a:extLst>
            </p:cNvPr>
            <p:cNvCxnSpPr>
              <a:cxnSpLocks/>
            </p:cNvCxnSpPr>
            <p:nvPr/>
          </p:nvCxnSpPr>
          <p:spPr>
            <a:xfrm>
              <a:off x="4852075" y="2608250"/>
              <a:ext cx="0" cy="2116629"/>
            </a:xfrm>
            <a:prstGeom prst="line">
              <a:avLst/>
            </a:prstGeom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6860797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</Words>
  <Application>Microsoft Office PowerPoint</Application>
  <PresentationFormat>Widescreen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ceves, Seema</dc:creator>
  <cp:lastModifiedBy>Aceves, Seema</cp:lastModifiedBy>
  <cp:revision>1</cp:revision>
  <dcterms:created xsi:type="dcterms:W3CDTF">2026-06-15T01:50:28Z</dcterms:created>
  <dcterms:modified xsi:type="dcterms:W3CDTF">2026-06-15T01:50:46Z</dcterms:modified>
</cp:coreProperties>
</file>